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9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E0E0"/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0598" autoAdjust="0"/>
  </p:normalViewPr>
  <p:slideViewPr>
    <p:cSldViewPr>
      <p:cViewPr>
        <p:scale>
          <a:sx n="110" d="100"/>
          <a:sy n="110" d="100"/>
        </p:scale>
        <p:origin x="-72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B7B53EF-3AE7-484E-9BAC-564CAAF4E700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DA31B0-2556-4684-8750-BF1D8261D7A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89989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60961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6762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7782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98881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62904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104353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1864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8313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91545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86925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6548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9BB526-5326-432C-B1B9-8029C7855CE6}" type="datetimeFigureOut">
              <a:rPr lang="it-IT" smtClean="0"/>
              <a:pPr/>
              <a:t>15/10/2018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159969-68B4-4155-962D-9F5BDCC23F08}" type="slidenum">
              <a:rPr lang="it-IT" smtClean="0"/>
              <a:pPr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75357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CasellaDiTesto 18"/>
          <p:cNvSpPr txBox="1"/>
          <p:nvPr/>
        </p:nvSpPr>
        <p:spPr>
          <a:xfrm>
            <a:off x="14432" y="115377"/>
            <a:ext cx="31683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it-IT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CasellaDiTesto 11"/>
          <p:cNvSpPr txBox="1"/>
          <p:nvPr/>
        </p:nvSpPr>
        <p:spPr>
          <a:xfrm>
            <a:off x="2123728" y="908720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/>
              <a:t>p=0.75</a:t>
            </a:r>
            <a:endParaRPr lang="it-IT" sz="1000" b="1" dirty="0"/>
          </a:p>
        </p:txBody>
      </p:sp>
      <p:sp>
        <p:nvSpPr>
          <p:cNvPr id="17" name="CasellaDiTesto 16"/>
          <p:cNvSpPr txBox="1"/>
          <p:nvPr/>
        </p:nvSpPr>
        <p:spPr>
          <a:xfrm>
            <a:off x="4788024" y="3315929"/>
            <a:ext cx="10081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 smtClean="0"/>
              <a:t>p=0.62</a:t>
            </a:r>
            <a:endParaRPr lang="it-IT" sz="1000" b="1" dirty="0"/>
          </a:p>
        </p:txBody>
      </p:sp>
      <p:grpSp>
        <p:nvGrpSpPr>
          <p:cNvPr id="33" name="Gruppo 32"/>
          <p:cNvGrpSpPr/>
          <p:nvPr/>
        </p:nvGrpSpPr>
        <p:grpSpPr>
          <a:xfrm>
            <a:off x="5436096" y="260648"/>
            <a:ext cx="2808312" cy="2520280"/>
            <a:chOff x="5436096" y="260648"/>
            <a:chExt cx="2808312" cy="2520280"/>
          </a:xfrm>
        </p:grpSpPr>
        <p:grpSp>
          <p:nvGrpSpPr>
            <p:cNvPr id="8" name="Gruppo 7"/>
            <p:cNvGrpSpPr/>
            <p:nvPr/>
          </p:nvGrpSpPr>
          <p:grpSpPr>
            <a:xfrm>
              <a:off x="5436096" y="260648"/>
              <a:ext cx="2808312" cy="2520280"/>
              <a:chOff x="5436096" y="260648"/>
              <a:chExt cx="2808312" cy="2520280"/>
            </a:xfrm>
          </p:grpSpPr>
          <p:pic>
            <p:nvPicPr>
              <p:cNvPr id="1029" name="Picture 5" descr="C:\Documents and Settings\Rosa\Desktop\fc okkkk.jpg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5436096" y="404664"/>
                <a:ext cx="2715455" cy="2355429"/>
              </a:xfrm>
              <a:prstGeom prst="rect">
                <a:avLst/>
              </a:prstGeom>
              <a:noFill/>
            </p:spPr>
          </p:pic>
          <p:sp>
            <p:nvSpPr>
              <p:cNvPr id="13" name="CasellaDiTesto 12"/>
              <p:cNvSpPr txBox="1"/>
              <p:nvPr/>
            </p:nvSpPr>
            <p:spPr>
              <a:xfrm>
                <a:off x="7236296" y="764704"/>
                <a:ext cx="10081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 smtClean="0"/>
                  <a:t>p=0.40</a:t>
                </a:r>
                <a:endParaRPr lang="it-IT" sz="1000" b="1" dirty="0"/>
              </a:p>
            </p:txBody>
          </p:sp>
          <p:grpSp>
            <p:nvGrpSpPr>
              <p:cNvPr id="22" name="Gruppo 21"/>
              <p:cNvGrpSpPr/>
              <p:nvPr/>
            </p:nvGrpSpPr>
            <p:grpSpPr>
              <a:xfrm>
                <a:off x="5457581" y="260648"/>
                <a:ext cx="338555" cy="2520280"/>
                <a:chOff x="489029" y="352134"/>
                <a:chExt cx="338555" cy="2520280"/>
              </a:xfrm>
            </p:grpSpPr>
            <p:sp>
              <p:nvSpPr>
                <p:cNvPr id="23" name="Rettangolo 22"/>
                <p:cNvSpPr/>
                <p:nvPr/>
              </p:nvSpPr>
              <p:spPr>
                <a:xfrm>
                  <a:off x="539552" y="764704"/>
                  <a:ext cx="288032" cy="158417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4" name="CasellaDiTesto 23"/>
                <p:cNvSpPr txBox="1"/>
                <p:nvPr/>
              </p:nvSpPr>
              <p:spPr>
                <a:xfrm rot="16200000">
                  <a:off x="-601834" y="1442997"/>
                  <a:ext cx="25202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800" b="1" dirty="0" err="1" smtClean="0"/>
                    <a:t>Tumoral</a:t>
                  </a:r>
                  <a:r>
                    <a:rPr lang="it-IT" sz="800" b="1" dirty="0" smtClean="0"/>
                    <a:t>/</a:t>
                  </a:r>
                  <a:r>
                    <a:rPr lang="it-IT" sz="800" b="1" dirty="0" err="1" smtClean="0"/>
                    <a:t>Peritumoral</a:t>
                  </a:r>
                  <a:endParaRPr lang="it-IT" sz="800" b="1" dirty="0" smtClean="0"/>
                </a:p>
                <a:p>
                  <a:pPr algn="ctr"/>
                  <a:r>
                    <a:rPr lang="it-IT" sz="800" b="1" dirty="0" err="1" smtClean="0"/>
                    <a:t>mRNA</a:t>
                  </a:r>
                  <a:r>
                    <a:rPr lang="it-IT" sz="800" b="1" dirty="0" smtClean="0"/>
                    <a:t> relative </a:t>
                  </a:r>
                  <a:r>
                    <a:rPr lang="it-IT" sz="800" b="1" dirty="0" err="1" smtClean="0"/>
                    <a:t>expression</a:t>
                  </a:r>
                  <a:r>
                    <a:rPr lang="it-IT" sz="800" b="1" dirty="0" smtClean="0"/>
                    <a:t> ratio</a:t>
                  </a:r>
                  <a:endParaRPr lang="it-IT" sz="800" b="1" dirty="0"/>
                </a:p>
              </p:txBody>
            </p:sp>
          </p:grpSp>
        </p:grpSp>
        <p:grpSp>
          <p:nvGrpSpPr>
            <p:cNvPr id="15" name="Gruppo 14"/>
            <p:cNvGrpSpPr/>
            <p:nvPr/>
          </p:nvGrpSpPr>
          <p:grpSpPr>
            <a:xfrm>
              <a:off x="6444208" y="404664"/>
              <a:ext cx="1512168" cy="315948"/>
              <a:chOff x="6444208" y="404664"/>
              <a:chExt cx="1512168" cy="315948"/>
            </a:xfrm>
          </p:grpSpPr>
          <p:sp>
            <p:nvSpPr>
              <p:cNvPr id="10" name="Rettangolo 9"/>
              <p:cNvSpPr/>
              <p:nvPr/>
            </p:nvSpPr>
            <p:spPr>
              <a:xfrm>
                <a:off x="6444208" y="404664"/>
                <a:ext cx="720080" cy="2685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9" name="CasellaDiTesto 8"/>
              <p:cNvSpPr txBox="1"/>
              <p:nvPr/>
            </p:nvSpPr>
            <p:spPr>
              <a:xfrm>
                <a:off x="6516216" y="443613"/>
                <a:ext cx="14401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c</a:t>
                </a:r>
                <a:r>
                  <a:rPr lang="el-G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γ</a:t>
                </a:r>
                <a:r>
                  <a:rPr lang="it-IT" sz="120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IIIa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2" name="Gruppo 31"/>
          <p:cNvGrpSpPr/>
          <p:nvPr/>
        </p:nvGrpSpPr>
        <p:grpSpPr>
          <a:xfrm>
            <a:off x="2915816" y="332656"/>
            <a:ext cx="2592288" cy="2520280"/>
            <a:chOff x="2915816" y="332656"/>
            <a:chExt cx="2592288" cy="2520280"/>
          </a:xfrm>
        </p:grpSpPr>
        <p:grpSp>
          <p:nvGrpSpPr>
            <p:cNvPr id="7" name="Gruppo 6"/>
            <p:cNvGrpSpPr/>
            <p:nvPr/>
          </p:nvGrpSpPr>
          <p:grpSpPr>
            <a:xfrm>
              <a:off x="2915816" y="332656"/>
              <a:ext cx="2592288" cy="2520280"/>
              <a:chOff x="2915816" y="332656"/>
              <a:chExt cx="2592288" cy="2520280"/>
            </a:xfrm>
          </p:grpSpPr>
          <p:pic>
            <p:nvPicPr>
              <p:cNvPr id="1028" name="Picture 4" descr="C:\Documents and Settings\Rosa\Desktop\dnam1 okkk.jpg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2915816" y="476672"/>
                <a:ext cx="2485206" cy="2271205"/>
              </a:xfrm>
              <a:prstGeom prst="rect">
                <a:avLst/>
              </a:prstGeom>
              <a:noFill/>
            </p:spPr>
          </p:pic>
          <p:sp>
            <p:nvSpPr>
              <p:cNvPr id="11" name="CasellaDiTesto 10"/>
              <p:cNvSpPr txBox="1"/>
              <p:nvPr/>
            </p:nvSpPr>
            <p:spPr>
              <a:xfrm>
                <a:off x="4499992" y="836712"/>
                <a:ext cx="10081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 smtClean="0"/>
                  <a:t>p=0.26</a:t>
                </a:r>
                <a:endParaRPr lang="it-IT" sz="1000" b="1" dirty="0"/>
              </a:p>
            </p:txBody>
          </p:sp>
          <p:grpSp>
            <p:nvGrpSpPr>
              <p:cNvPr id="18" name="Gruppo 17"/>
              <p:cNvGrpSpPr/>
              <p:nvPr/>
            </p:nvGrpSpPr>
            <p:grpSpPr>
              <a:xfrm>
                <a:off x="2915816" y="332656"/>
                <a:ext cx="338555" cy="2520280"/>
                <a:chOff x="489029" y="352134"/>
                <a:chExt cx="338555" cy="2520280"/>
              </a:xfrm>
            </p:grpSpPr>
            <p:sp>
              <p:nvSpPr>
                <p:cNvPr id="20" name="Rettangolo 19"/>
                <p:cNvSpPr/>
                <p:nvPr/>
              </p:nvSpPr>
              <p:spPr>
                <a:xfrm>
                  <a:off x="539552" y="764704"/>
                  <a:ext cx="288032" cy="158417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1" name="CasellaDiTesto 20"/>
                <p:cNvSpPr txBox="1"/>
                <p:nvPr/>
              </p:nvSpPr>
              <p:spPr>
                <a:xfrm rot="16200000">
                  <a:off x="-601834" y="1442997"/>
                  <a:ext cx="25202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800" b="1" dirty="0" err="1" smtClean="0"/>
                    <a:t>Tumoral</a:t>
                  </a:r>
                  <a:r>
                    <a:rPr lang="it-IT" sz="800" b="1" dirty="0" smtClean="0"/>
                    <a:t>/</a:t>
                  </a:r>
                  <a:r>
                    <a:rPr lang="it-IT" sz="800" b="1" dirty="0" err="1" smtClean="0"/>
                    <a:t>Peritumoral</a:t>
                  </a:r>
                  <a:endParaRPr lang="it-IT" sz="800" b="1" dirty="0" smtClean="0"/>
                </a:p>
                <a:p>
                  <a:pPr algn="ctr"/>
                  <a:r>
                    <a:rPr lang="it-IT" sz="800" b="1" dirty="0" err="1" smtClean="0"/>
                    <a:t>mRNA</a:t>
                  </a:r>
                  <a:r>
                    <a:rPr lang="it-IT" sz="800" b="1" dirty="0" smtClean="0"/>
                    <a:t> relative </a:t>
                  </a:r>
                  <a:r>
                    <a:rPr lang="it-IT" sz="800" b="1" dirty="0" err="1" smtClean="0"/>
                    <a:t>expression</a:t>
                  </a:r>
                  <a:r>
                    <a:rPr lang="it-IT" sz="800" b="1" dirty="0" smtClean="0"/>
                    <a:t> ratio</a:t>
                  </a:r>
                  <a:endParaRPr lang="it-IT" sz="800" b="1" dirty="0"/>
                </a:p>
              </p:txBody>
            </p:sp>
          </p:grpSp>
        </p:grpSp>
        <p:grpSp>
          <p:nvGrpSpPr>
            <p:cNvPr id="36" name="Gruppo 35"/>
            <p:cNvGrpSpPr/>
            <p:nvPr/>
          </p:nvGrpSpPr>
          <p:grpSpPr>
            <a:xfrm>
              <a:off x="3748307" y="459281"/>
              <a:ext cx="1512168" cy="315948"/>
              <a:chOff x="6444208" y="404664"/>
              <a:chExt cx="1512168" cy="315948"/>
            </a:xfrm>
          </p:grpSpPr>
          <p:sp>
            <p:nvSpPr>
              <p:cNvPr id="37" name="Rettangolo 36"/>
              <p:cNvSpPr/>
              <p:nvPr/>
            </p:nvSpPr>
            <p:spPr>
              <a:xfrm>
                <a:off x="6444208" y="404664"/>
                <a:ext cx="720080" cy="2685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38" name="CasellaDiTesto 37"/>
              <p:cNvSpPr txBox="1"/>
              <p:nvPr/>
            </p:nvSpPr>
            <p:spPr>
              <a:xfrm>
                <a:off x="6516216" y="443613"/>
                <a:ext cx="14401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M-1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5" name="Gruppo 34"/>
          <p:cNvGrpSpPr/>
          <p:nvPr/>
        </p:nvGrpSpPr>
        <p:grpSpPr>
          <a:xfrm>
            <a:off x="605427" y="2782972"/>
            <a:ext cx="2562925" cy="2520280"/>
            <a:chOff x="605427" y="2782972"/>
            <a:chExt cx="2562925" cy="2520280"/>
          </a:xfrm>
        </p:grpSpPr>
        <p:grpSp>
          <p:nvGrpSpPr>
            <p:cNvPr id="5" name="Gruppo 4"/>
            <p:cNvGrpSpPr/>
            <p:nvPr/>
          </p:nvGrpSpPr>
          <p:grpSpPr>
            <a:xfrm>
              <a:off x="605427" y="2782972"/>
              <a:ext cx="2562925" cy="2520280"/>
              <a:chOff x="605427" y="2782972"/>
              <a:chExt cx="2562925" cy="2520280"/>
            </a:xfrm>
          </p:grpSpPr>
          <p:pic>
            <p:nvPicPr>
              <p:cNvPr id="1032" name="Picture 8" descr="C:\Documents and Settings\Rosa\Desktop\nkp44 okkk.jpg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83568" y="3083389"/>
                <a:ext cx="2376264" cy="2160240"/>
              </a:xfrm>
              <a:prstGeom prst="rect">
                <a:avLst/>
              </a:prstGeom>
              <a:noFill/>
            </p:spPr>
          </p:pic>
          <p:sp>
            <p:nvSpPr>
              <p:cNvPr id="16" name="CasellaDiTesto 15"/>
              <p:cNvSpPr txBox="1"/>
              <p:nvPr/>
            </p:nvSpPr>
            <p:spPr>
              <a:xfrm>
                <a:off x="2160240" y="3329610"/>
                <a:ext cx="100811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000" b="1" dirty="0" smtClean="0"/>
                  <a:t>p=0.22</a:t>
                </a:r>
                <a:endParaRPr lang="it-IT" sz="1000" b="1" dirty="0"/>
              </a:p>
            </p:txBody>
          </p:sp>
          <p:grpSp>
            <p:nvGrpSpPr>
              <p:cNvPr id="25" name="Gruppo 24"/>
              <p:cNvGrpSpPr/>
              <p:nvPr/>
            </p:nvGrpSpPr>
            <p:grpSpPr>
              <a:xfrm>
                <a:off x="605427" y="2782972"/>
                <a:ext cx="401344" cy="2520280"/>
                <a:chOff x="426240" y="354178"/>
                <a:chExt cx="401344" cy="2520280"/>
              </a:xfrm>
            </p:grpSpPr>
            <p:sp>
              <p:nvSpPr>
                <p:cNvPr id="26" name="Rettangolo 25"/>
                <p:cNvSpPr/>
                <p:nvPr/>
              </p:nvSpPr>
              <p:spPr>
                <a:xfrm>
                  <a:off x="539552" y="764704"/>
                  <a:ext cx="288032" cy="158417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27" name="CasellaDiTesto 26"/>
                <p:cNvSpPr txBox="1"/>
                <p:nvPr/>
              </p:nvSpPr>
              <p:spPr>
                <a:xfrm rot="16200000">
                  <a:off x="-664623" y="1445041"/>
                  <a:ext cx="25202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800" b="1" dirty="0" err="1" smtClean="0"/>
                    <a:t>Tumoral</a:t>
                  </a:r>
                  <a:r>
                    <a:rPr lang="it-IT" sz="800" b="1" dirty="0" smtClean="0"/>
                    <a:t>/</a:t>
                  </a:r>
                  <a:r>
                    <a:rPr lang="it-IT" sz="800" b="1" dirty="0" err="1" smtClean="0"/>
                    <a:t>Peritumoral</a:t>
                  </a:r>
                  <a:endParaRPr lang="it-IT" sz="800" b="1" dirty="0" smtClean="0"/>
                </a:p>
                <a:p>
                  <a:pPr algn="ctr"/>
                  <a:r>
                    <a:rPr lang="it-IT" sz="800" b="1" dirty="0" err="1" smtClean="0"/>
                    <a:t>mRNA</a:t>
                  </a:r>
                  <a:r>
                    <a:rPr lang="it-IT" sz="800" b="1" dirty="0" smtClean="0"/>
                    <a:t> relative </a:t>
                  </a:r>
                  <a:r>
                    <a:rPr lang="it-IT" sz="800" b="1" dirty="0" err="1" smtClean="0"/>
                    <a:t>expression</a:t>
                  </a:r>
                  <a:r>
                    <a:rPr lang="it-IT" sz="800" b="1" dirty="0" smtClean="0"/>
                    <a:t> ratio</a:t>
                  </a:r>
                  <a:endParaRPr lang="it-IT" sz="800" b="1" dirty="0"/>
                </a:p>
              </p:txBody>
            </p:sp>
          </p:grpSp>
        </p:grpSp>
        <p:grpSp>
          <p:nvGrpSpPr>
            <p:cNvPr id="39" name="Gruppo 38"/>
            <p:cNvGrpSpPr/>
            <p:nvPr/>
          </p:nvGrpSpPr>
          <p:grpSpPr>
            <a:xfrm>
              <a:off x="1576560" y="2992714"/>
              <a:ext cx="1555280" cy="336896"/>
              <a:chOff x="6444208" y="404663"/>
              <a:chExt cx="1555280" cy="336896"/>
            </a:xfrm>
          </p:grpSpPr>
          <p:sp>
            <p:nvSpPr>
              <p:cNvPr id="40" name="Rettangolo 39"/>
              <p:cNvSpPr/>
              <p:nvPr/>
            </p:nvSpPr>
            <p:spPr>
              <a:xfrm>
                <a:off x="6444208" y="404663"/>
                <a:ext cx="720080" cy="336895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1" name="CasellaDiTesto 40"/>
              <p:cNvSpPr txBox="1"/>
              <p:nvPr/>
            </p:nvSpPr>
            <p:spPr>
              <a:xfrm>
                <a:off x="6559328" y="464560"/>
                <a:ext cx="14401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Kp44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1" name="Gruppo 30"/>
          <p:cNvGrpSpPr/>
          <p:nvPr/>
        </p:nvGrpSpPr>
        <p:grpSpPr>
          <a:xfrm>
            <a:off x="514290" y="352134"/>
            <a:ext cx="2430433" cy="2520280"/>
            <a:chOff x="514290" y="352134"/>
            <a:chExt cx="2430433" cy="2520280"/>
          </a:xfrm>
        </p:grpSpPr>
        <p:grpSp>
          <p:nvGrpSpPr>
            <p:cNvPr id="6" name="Gruppo 5"/>
            <p:cNvGrpSpPr/>
            <p:nvPr/>
          </p:nvGrpSpPr>
          <p:grpSpPr>
            <a:xfrm>
              <a:off x="514290" y="352134"/>
              <a:ext cx="2401526" cy="2520280"/>
              <a:chOff x="514290" y="352134"/>
              <a:chExt cx="2401526" cy="2520280"/>
            </a:xfrm>
          </p:grpSpPr>
          <p:pic>
            <p:nvPicPr>
              <p:cNvPr id="1027" name="Picture 3" descr="C:\Documents and Settings\Rosa\Desktop\ncam-1 okkkk.jpg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39552" y="548680"/>
                <a:ext cx="2376264" cy="2205225"/>
              </a:xfrm>
              <a:prstGeom prst="rect">
                <a:avLst/>
              </a:prstGeom>
              <a:noFill/>
            </p:spPr>
          </p:pic>
          <p:grpSp>
            <p:nvGrpSpPr>
              <p:cNvPr id="3" name="Gruppo 2"/>
              <p:cNvGrpSpPr/>
              <p:nvPr/>
            </p:nvGrpSpPr>
            <p:grpSpPr>
              <a:xfrm>
                <a:off x="514290" y="352134"/>
                <a:ext cx="338555" cy="2520280"/>
                <a:chOff x="489029" y="352134"/>
                <a:chExt cx="338555" cy="2520280"/>
              </a:xfrm>
            </p:grpSpPr>
            <p:sp>
              <p:nvSpPr>
                <p:cNvPr id="2" name="Rettangolo 1"/>
                <p:cNvSpPr/>
                <p:nvPr/>
              </p:nvSpPr>
              <p:spPr>
                <a:xfrm>
                  <a:off x="539552" y="764704"/>
                  <a:ext cx="288032" cy="158417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14" name="CasellaDiTesto 13"/>
                <p:cNvSpPr txBox="1"/>
                <p:nvPr/>
              </p:nvSpPr>
              <p:spPr>
                <a:xfrm rot="16200000">
                  <a:off x="-601834" y="1442997"/>
                  <a:ext cx="25202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800" b="1" dirty="0" err="1" smtClean="0"/>
                    <a:t>Tumoral</a:t>
                  </a:r>
                  <a:r>
                    <a:rPr lang="it-IT" sz="800" b="1" dirty="0" smtClean="0"/>
                    <a:t>/</a:t>
                  </a:r>
                  <a:r>
                    <a:rPr lang="it-IT" sz="800" b="1" dirty="0" err="1" smtClean="0"/>
                    <a:t>Peritumoral</a:t>
                  </a:r>
                  <a:endParaRPr lang="it-IT" sz="800" b="1" dirty="0" smtClean="0"/>
                </a:p>
                <a:p>
                  <a:pPr algn="ctr"/>
                  <a:r>
                    <a:rPr lang="it-IT" sz="800" b="1" dirty="0" err="1" smtClean="0"/>
                    <a:t>mRNA</a:t>
                  </a:r>
                  <a:r>
                    <a:rPr lang="it-IT" sz="800" b="1" dirty="0" smtClean="0"/>
                    <a:t> relative </a:t>
                  </a:r>
                  <a:r>
                    <a:rPr lang="it-IT" sz="800" b="1" dirty="0" err="1" smtClean="0"/>
                    <a:t>expression</a:t>
                  </a:r>
                  <a:r>
                    <a:rPr lang="it-IT" sz="800" b="1" dirty="0" smtClean="0"/>
                    <a:t> ratio</a:t>
                  </a:r>
                  <a:endParaRPr lang="it-IT" sz="800" b="1" dirty="0"/>
                </a:p>
              </p:txBody>
            </p:sp>
          </p:grpSp>
        </p:grpSp>
        <p:grpSp>
          <p:nvGrpSpPr>
            <p:cNvPr id="42" name="Gruppo 41"/>
            <p:cNvGrpSpPr/>
            <p:nvPr/>
          </p:nvGrpSpPr>
          <p:grpSpPr>
            <a:xfrm>
              <a:off x="1448036" y="548680"/>
              <a:ext cx="1496687" cy="370504"/>
              <a:chOff x="6444208" y="302714"/>
              <a:chExt cx="1496687" cy="370504"/>
            </a:xfrm>
          </p:grpSpPr>
          <p:sp>
            <p:nvSpPr>
              <p:cNvPr id="43" name="Rettangolo 42"/>
              <p:cNvSpPr/>
              <p:nvPr/>
            </p:nvSpPr>
            <p:spPr>
              <a:xfrm>
                <a:off x="6444208" y="404664"/>
                <a:ext cx="720080" cy="2685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4" name="CasellaDiTesto 43"/>
              <p:cNvSpPr txBox="1"/>
              <p:nvPr/>
            </p:nvSpPr>
            <p:spPr>
              <a:xfrm>
                <a:off x="6500735" y="302714"/>
                <a:ext cx="14401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CAM-1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" name="Gruppo 33"/>
          <p:cNvGrpSpPr/>
          <p:nvPr/>
        </p:nvGrpSpPr>
        <p:grpSpPr>
          <a:xfrm>
            <a:off x="3348000" y="2801949"/>
            <a:ext cx="2196108" cy="2520280"/>
            <a:chOff x="3348000" y="2801949"/>
            <a:chExt cx="2196108" cy="2520280"/>
          </a:xfrm>
        </p:grpSpPr>
        <p:grpSp>
          <p:nvGrpSpPr>
            <p:cNvPr id="4" name="Gruppo 3"/>
            <p:cNvGrpSpPr/>
            <p:nvPr/>
          </p:nvGrpSpPr>
          <p:grpSpPr>
            <a:xfrm>
              <a:off x="3348000" y="2801949"/>
              <a:ext cx="2160104" cy="2520280"/>
              <a:chOff x="3348000" y="2801949"/>
              <a:chExt cx="2160104" cy="2520280"/>
            </a:xfrm>
          </p:grpSpPr>
          <p:pic>
            <p:nvPicPr>
              <p:cNvPr id="1033" name="Picture 9" descr="C:\Documents and Settings\Rosa\Desktop\nkg2d okkk.jpg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3428627" y="3083389"/>
                <a:ext cx="2079477" cy="2160240"/>
              </a:xfrm>
              <a:prstGeom prst="rect">
                <a:avLst/>
              </a:prstGeom>
              <a:noFill/>
            </p:spPr>
          </p:pic>
          <p:grpSp>
            <p:nvGrpSpPr>
              <p:cNvPr id="28" name="Gruppo 27"/>
              <p:cNvGrpSpPr/>
              <p:nvPr/>
            </p:nvGrpSpPr>
            <p:grpSpPr>
              <a:xfrm>
                <a:off x="3348000" y="2801949"/>
                <a:ext cx="359904" cy="2520280"/>
                <a:chOff x="460975" y="589179"/>
                <a:chExt cx="359904" cy="2520280"/>
              </a:xfrm>
            </p:grpSpPr>
            <p:sp>
              <p:nvSpPr>
                <p:cNvPr id="29" name="Rettangolo 28"/>
                <p:cNvSpPr/>
                <p:nvPr/>
              </p:nvSpPr>
              <p:spPr>
                <a:xfrm>
                  <a:off x="539552" y="764704"/>
                  <a:ext cx="281327" cy="18002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it-IT"/>
                </a:p>
              </p:txBody>
            </p:sp>
            <p:sp>
              <p:nvSpPr>
                <p:cNvPr id="30" name="CasellaDiTesto 29"/>
                <p:cNvSpPr txBox="1"/>
                <p:nvPr/>
              </p:nvSpPr>
              <p:spPr>
                <a:xfrm rot="16200000">
                  <a:off x="-629888" y="1680042"/>
                  <a:ext cx="2520280" cy="33855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it-IT" sz="800" b="1" dirty="0" err="1" smtClean="0"/>
                    <a:t>Tumoral</a:t>
                  </a:r>
                  <a:r>
                    <a:rPr lang="it-IT" sz="800" b="1" dirty="0" smtClean="0"/>
                    <a:t>/</a:t>
                  </a:r>
                  <a:r>
                    <a:rPr lang="it-IT" sz="800" b="1" dirty="0" err="1" smtClean="0"/>
                    <a:t>Peritumoral</a:t>
                  </a:r>
                  <a:endParaRPr lang="it-IT" sz="800" b="1" dirty="0" smtClean="0"/>
                </a:p>
                <a:p>
                  <a:pPr algn="ctr"/>
                  <a:r>
                    <a:rPr lang="it-IT" sz="800" b="1" dirty="0" err="1" smtClean="0"/>
                    <a:t>mRNA</a:t>
                  </a:r>
                  <a:r>
                    <a:rPr lang="it-IT" sz="800" b="1" dirty="0" smtClean="0"/>
                    <a:t> relative </a:t>
                  </a:r>
                  <a:r>
                    <a:rPr lang="it-IT" sz="800" b="1" dirty="0" err="1" smtClean="0"/>
                    <a:t>expression</a:t>
                  </a:r>
                  <a:r>
                    <a:rPr lang="it-IT" sz="800" b="1" dirty="0" smtClean="0"/>
                    <a:t> ratio</a:t>
                  </a:r>
                  <a:endParaRPr lang="it-IT" sz="800" b="1" dirty="0"/>
                </a:p>
              </p:txBody>
            </p:sp>
          </p:grpSp>
        </p:grpSp>
        <p:grpSp>
          <p:nvGrpSpPr>
            <p:cNvPr id="45" name="Gruppo 44"/>
            <p:cNvGrpSpPr/>
            <p:nvPr/>
          </p:nvGrpSpPr>
          <p:grpSpPr>
            <a:xfrm>
              <a:off x="4031940" y="3050776"/>
              <a:ext cx="1512168" cy="315948"/>
              <a:chOff x="6444208" y="404664"/>
              <a:chExt cx="1512168" cy="315948"/>
            </a:xfrm>
          </p:grpSpPr>
          <p:sp>
            <p:nvSpPr>
              <p:cNvPr id="46" name="Rettangolo 45"/>
              <p:cNvSpPr/>
              <p:nvPr/>
            </p:nvSpPr>
            <p:spPr>
              <a:xfrm>
                <a:off x="6444208" y="404664"/>
                <a:ext cx="720080" cy="2685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47" name="CasellaDiTesto 46"/>
              <p:cNvSpPr txBox="1"/>
              <p:nvPr/>
            </p:nvSpPr>
            <p:spPr>
              <a:xfrm>
                <a:off x="6516216" y="443613"/>
                <a:ext cx="144016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KG2D</a:t>
                </a:r>
                <a:endParaRPr lang="it-IT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6499459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378</TotalTime>
  <Words>39</Words>
  <Application>Microsoft Office PowerPoint</Application>
  <PresentationFormat>Presentazione su schermo (4:3)</PresentationFormat>
  <Paragraphs>2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ALA</dc:creator>
  <cp:lastModifiedBy>Genomica Funzionale</cp:lastModifiedBy>
  <cp:revision>617</cp:revision>
  <dcterms:created xsi:type="dcterms:W3CDTF">2016-04-07T07:01:43Z</dcterms:created>
  <dcterms:modified xsi:type="dcterms:W3CDTF">2018-10-15T15:08:59Z</dcterms:modified>
</cp:coreProperties>
</file>